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7" autoAdjust="0"/>
    <p:restoredTop sz="94660"/>
  </p:normalViewPr>
  <p:slideViewPr>
    <p:cSldViewPr snapToGrid="0">
      <p:cViewPr varScale="1">
        <p:scale>
          <a:sx n="78" d="100"/>
          <a:sy n="78" d="100"/>
        </p:scale>
        <p:origin x="40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497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074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772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607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280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4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973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985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955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944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202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7F4625-A46A-4A31-A049-EEA01D19FB5B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580C36-0146-417D-84B1-D29658EEE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859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660A980A-D0CA-4462-B8DD-2FDA4C9B7898}"/>
              </a:ext>
            </a:extLst>
          </p:cNvPr>
          <p:cNvSpPr txBox="1"/>
          <p:nvPr/>
        </p:nvSpPr>
        <p:spPr>
          <a:xfrm>
            <a:off x="858191" y="5125168"/>
            <a:ext cx="644637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 1. Huma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hymopoiesi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n NRG-hu HSC/Thy mic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NRG-hu HSC/Thy mice were generated as described in the Methods part. (A) Thymus organoid harvested 20 weeks post transplant (left) consists almost exclusively of human CD45+ cells (right). B, Number of human CD45+ thymocytes recovered from each mouse (n=12). C-D, Representative FACS plot (C) and summarized data (D) show the expression of human CD4 and CD8 antigen in thymocytes recovered from NRG-hu HSC/Thy mice. SP4: CD4 single positive; SP8: CD8 single positive; DP: double positive; L/D: live/dead cell staining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86C6EED-5AB5-492D-83EB-A3EF76225DE4}"/>
              </a:ext>
            </a:extLst>
          </p:cNvPr>
          <p:cNvSpPr txBox="1"/>
          <p:nvPr/>
        </p:nvSpPr>
        <p:spPr>
          <a:xfrm>
            <a:off x="5899618" y="-19058"/>
            <a:ext cx="3342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 Cheng et al.  Supplemental Fig. 1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C25FE906-01E3-404D-89DB-0927E134800E}"/>
              </a:ext>
            </a:extLst>
          </p:cNvPr>
          <p:cNvGrpSpPr/>
          <p:nvPr/>
        </p:nvGrpSpPr>
        <p:grpSpPr>
          <a:xfrm>
            <a:off x="1490813" y="3255023"/>
            <a:ext cx="1399483" cy="1962824"/>
            <a:chOff x="1222841" y="1345672"/>
            <a:chExt cx="1399483" cy="1962824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D8FA679-2251-453B-959F-F2FC3763EFBE}"/>
                </a:ext>
              </a:extLst>
            </p:cNvPr>
            <p:cNvSpPr txBox="1"/>
            <p:nvPr/>
          </p:nvSpPr>
          <p:spPr>
            <a:xfrm>
              <a:off x="1222841" y="134567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AF36ABD0-5CAB-4AA1-87C3-41B9AB65CB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95373" y="1485560"/>
              <a:ext cx="1226951" cy="1822936"/>
            </a:xfrm>
            <a:prstGeom prst="rect">
              <a:avLst/>
            </a:prstGeom>
          </p:spPr>
        </p:pic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EFAA0212-C6C5-46FC-82DF-4F792E2B8E4C}"/>
              </a:ext>
            </a:extLst>
          </p:cNvPr>
          <p:cNvGrpSpPr/>
          <p:nvPr/>
        </p:nvGrpSpPr>
        <p:grpSpPr>
          <a:xfrm>
            <a:off x="4302810" y="1661232"/>
            <a:ext cx="1578712" cy="1519807"/>
            <a:chOff x="3549047" y="1661232"/>
            <a:chExt cx="1578712" cy="1519807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212BB5C5-3091-4068-A23C-0E8CE14626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9679" t="12537" b="15284"/>
            <a:stretch/>
          </p:blipFill>
          <p:spPr>
            <a:xfrm>
              <a:off x="3765952" y="1661232"/>
              <a:ext cx="1361807" cy="1306272"/>
            </a:xfrm>
            <a:prstGeom prst="rect">
              <a:avLst/>
            </a:prstGeom>
            <a:noFill/>
          </p:spPr>
        </p:pic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A9FD664A-3C5E-41B2-AC59-D52042E36D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633423" y="3042540"/>
              <a:ext cx="350011" cy="262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A7E95B47-0F62-4BD6-B09A-B48D1F64085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75662" y="1907294"/>
              <a:ext cx="0" cy="48803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65">
              <a:extLst>
                <a:ext uri="{FF2B5EF4-FFF2-40B4-BE49-F238E27FC236}">
                  <a16:creationId xmlns:a16="http://schemas.microsoft.com/office/drawing/2014/main" id="{E9664547-145B-4130-B8DF-E368362C54CB}"/>
                </a:ext>
              </a:extLst>
            </p:cNvPr>
            <p:cNvSpPr txBox="1"/>
            <p:nvPr/>
          </p:nvSpPr>
          <p:spPr>
            <a:xfrm>
              <a:off x="3667055" y="2904040"/>
              <a:ext cx="10326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CD45+L/D</a:t>
              </a:r>
            </a:p>
          </p:txBody>
        </p:sp>
        <p:sp>
          <p:nvSpPr>
            <p:cNvPr id="34" name="TextBox 66">
              <a:extLst>
                <a:ext uri="{FF2B5EF4-FFF2-40B4-BE49-F238E27FC236}">
                  <a16:creationId xmlns:a16="http://schemas.microsoft.com/office/drawing/2014/main" id="{ABF0782E-C16F-4807-A8AE-C3E7A64C74CE}"/>
                </a:ext>
              </a:extLst>
            </p:cNvPr>
            <p:cNvSpPr txBox="1"/>
            <p:nvPr/>
          </p:nvSpPr>
          <p:spPr>
            <a:xfrm rot="16023739">
              <a:off x="3357168" y="2572614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CD45</a:t>
              </a:r>
            </a:p>
          </p:txBody>
        </p:sp>
        <p:sp>
          <p:nvSpPr>
            <p:cNvPr id="35" name="TextBox 67">
              <a:extLst>
                <a:ext uri="{FF2B5EF4-FFF2-40B4-BE49-F238E27FC236}">
                  <a16:creationId xmlns:a16="http://schemas.microsoft.com/office/drawing/2014/main" id="{985005FE-5C30-42B2-A55C-FB91626558F3}"/>
                </a:ext>
              </a:extLst>
            </p:cNvPr>
            <p:cNvSpPr txBox="1"/>
            <p:nvPr/>
          </p:nvSpPr>
          <p:spPr>
            <a:xfrm>
              <a:off x="3833611" y="1819064"/>
              <a:ext cx="6460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defTabSz="914400"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defTabSz="914400"/>
              <a:lvl3pPr defTabSz="914400"/>
              <a:lvl4pPr defTabSz="914400"/>
              <a:lvl5pPr defTabSz="914400"/>
              <a:lvl6pPr defTabSz="914400"/>
              <a:lvl7pPr defTabSz="914400"/>
              <a:lvl8pPr defTabSz="914400"/>
              <a:lvl9pPr defTabSz="914400"/>
            </a:lstStyle>
            <a:p>
              <a:r>
                <a:rPr lang="en-US" dirty="0"/>
                <a:t>86.7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D330D29-A5F1-44CE-9171-78ED56F1E814}"/>
              </a:ext>
            </a:extLst>
          </p:cNvPr>
          <p:cNvGrpSpPr/>
          <p:nvPr/>
        </p:nvGrpSpPr>
        <p:grpSpPr>
          <a:xfrm>
            <a:off x="3089189" y="3521428"/>
            <a:ext cx="1554828" cy="1505293"/>
            <a:chOff x="4721686" y="2683610"/>
            <a:chExt cx="1554828" cy="1505293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3C59BA8C-F80A-4619-BB9F-8E20B51235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6278" t="12537" b="16086"/>
            <a:stretch/>
          </p:blipFill>
          <p:spPr>
            <a:xfrm>
              <a:off x="4927166" y="2683610"/>
              <a:ext cx="1349348" cy="1291753"/>
            </a:xfrm>
            <a:prstGeom prst="rect">
              <a:avLst/>
            </a:prstGeom>
          </p:spPr>
        </p:pic>
        <p:sp>
          <p:nvSpPr>
            <p:cNvPr id="38" name="TextBox 58">
              <a:extLst>
                <a:ext uri="{FF2B5EF4-FFF2-40B4-BE49-F238E27FC236}">
                  <a16:creationId xmlns:a16="http://schemas.microsoft.com/office/drawing/2014/main" id="{F7C7BE42-9F65-44A5-A5DC-53DF06372CCF}"/>
                </a:ext>
              </a:extLst>
            </p:cNvPr>
            <p:cNvSpPr txBox="1"/>
            <p:nvPr/>
          </p:nvSpPr>
          <p:spPr>
            <a:xfrm>
              <a:off x="4927166" y="2843960"/>
              <a:ext cx="5014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4.4</a:t>
              </a:r>
            </a:p>
          </p:txBody>
        </p:sp>
        <p:sp>
          <p:nvSpPr>
            <p:cNvPr id="39" name="TextBox 59">
              <a:extLst>
                <a:ext uri="{FF2B5EF4-FFF2-40B4-BE49-F238E27FC236}">
                  <a16:creationId xmlns:a16="http://schemas.microsoft.com/office/drawing/2014/main" id="{6B3EB2BE-65F7-43DD-8A5F-263846FE2305}"/>
                </a:ext>
              </a:extLst>
            </p:cNvPr>
            <p:cNvSpPr txBox="1"/>
            <p:nvPr/>
          </p:nvSpPr>
          <p:spPr>
            <a:xfrm>
              <a:off x="5855081" y="3584552"/>
              <a:ext cx="421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.5</a:t>
              </a:r>
            </a:p>
          </p:txBody>
        </p:sp>
        <p:sp>
          <p:nvSpPr>
            <p:cNvPr id="40" name="TextBox 61">
              <a:extLst>
                <a:ext uri="{FF2B5EF4-FFF2-40B4-BE49-F238E27FC236}">
                  <a16:creationId xmlns:a16="http://schemas.microsoft.com/office/drawing/2014/main" id="{7DAEDCCA-5288-4ADA-8A74-AD9AD88B1319}"/>
                </a:ext>
              </a:extLst>
            </p:cNvPr>
            <p:cNvSpPr txBox="1"/>
            <p:nvPr/>
          </p:nvSpPr>
          <p:spPr>
            <a:xfrm>
              <a:off x="5563436" y="2783299"/>
              <a:ext cx="5782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8.7</a:t>
              </a:r>
            </a:p>
          </p:txBody>
        </p: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47E233B2-FC4F-4638-A3FF-533E549C6ADC}"/>
                </a:ext>
              </a:extLst>
            </p:cNvPr>
            <p:cNvCxnSpPr>
              <a:cxnSpLocks/>
            </p:cNvCxnSpPr>
            <p:nvPr/>
          </p:nvCxnSpPr>
          <p:spPr>
            <a:xfrm>
              <a:off x="5292435" y="4050404"/>
              <a:ext cx="8255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19F02062-735D-497D-82DB-CF04418CD0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48302" y="3004058"/>
              <a:ext cx="0" cy="48803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65">
              <a:extLst>
                <a:ext uri="{FF2B5EF4-FFF2-40B4-BE49-F238E27FC236}">
                  <a16:creationId xmlns:a16="http://schemas.microsoft.com/office/drawing/2014/main" id="{1096C0F7-6F12-41A6-8398-A8D56769662F}"/>
                </a:ext>
              </a:extLst>
            </p:cNvPr>
            <p:cNvSpPr txBox="1"/>
            <p:nvPr/>
          </p:nvSpPr>
          <p:spPr>
            <a:xfrm>
              <a:off x="4839695" y="391190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sp>
          <p:nvSpPr>
            <p:cNvPr id="44" name="TextBox 66">
              <a:extLst>
                <a:ext uri="{FF2B5EF4-FFF2-40B4-BE49-F238E27FC236}">
                  <a16:creationId xmlns:a16="http://schemas.microsoft.com/office/drawing/2014/main" id="{2B163BFE-BAD0-4770-B68E-390A3DA0C587}"/>
                </a:ext>
              </a:extLst>
            </p:cNvPr>
            <p:cNvSpPr txBox="1"/>
            <p:nvPr/>
          </p:nvSpPr>
          <p:spPr>
            <a:xfrm rot="16023739">
              <a:off x="4614766" y="3580478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7EAC48B6-ACEB-4AE9-AA13-1FF77E67B1D7}"/>
              </a:ext>
            </a:extLst>
          </p:cNvPr>
          <p:cNvGrpSpPr/>
          <p:nvPr/>
        </p:nvGrpSpPr>
        <p:grpSpPr>
          <a:xfrm>
            <a:off x="2845162" y="3251894"/>
            <a:ext cx="3037474" cy="1940299"/>
            <a:chOff x="4860804" y="1425176"/>
            <a:chExt cx="3037474" cy="1940299"/>
          </a:xfrm>
        </p:grpSpPr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11E6C98A-F291-4818-8CD4-030A16927CD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616457" y="1425176"/>
              <a:ext cx="1281821" cy="1940299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C6EC2CD-013A-4F4C-8184-44E52227E338}"/>
                </a:ext>
              </a:extLst>
            </p:cNvPr>
            <p:cNvSpPr txBox="1"/>
            <p:nvPr/>
          </p:nvSpPr>
          <p:spPr>
            <a:xfrm>
              <a:off x="4860804" y="144973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042CDF87-20B4-4415-8E16-0D0A34CE8467}"/>
              </a:ext>
            </a:extLst>
          </p:cNvPr>
          <p:cNvSpPr txBox="1"/>
          <p:nvPr/>
        </p:nvSpPr>
        <p:spPr>
          <a:xfrm>
            <a:off x="1534995" y="122746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82DA37B-6959-4754-8D79-3B535AB0343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01116" y="1544899"/>
            <a:ext cx="1472300" cy="160220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1D5DA15-629E-4BCC-AE11-0716D9D87381}"/>
              </a:ext>
            </a:extLst>
          </p:cNvPr>
          <p:cNvSpPr/>
          <p:nvPr/>
        </p:nvSpPr>
        <p:spPr>
          <a:xfrm>
            <a:off x="1849354" y="1292557"/>
            <a:ext cx="14895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SC/Thy organoid </a:t>
            </a:r>
          </a:p>
        </p:txBody>
      </p:sp>
      <p:sp>
        <p:nvSpPr>
          <p:cNvPr id="6" name="Freeform: Shape 5">
            <a:extLst>
              <a:ext uri="{FF2B5EF4-FFF2-40B4-BE49-F238E27FC236}">
                <a16:creationId xmlns:a16="http://schemas.microsoft.com/office/drawing/2014/main" id="{727FF46A-87C4-4ADC-9F01-01BB4943FADA}"/>
              </a:ext>
            </a:extLst>
          </p:cNvPr>
          <p:cNvSpPr/>
          <p:nvPr/>
        </p:nvSpPr>
        <p:spPr>
          <a:xfrm>
            <a:off x="1940011" y="2323070"/>
            <a:ext cx="1149178" cy="444844"/>
          </a:xfrm>
          <a:custGeom>
            <a:avLst/>
            <a:gdLst>
              <a:gd name="connsiteX0" fmla="*/ 111211 w 1149178"/>
              <a:gd name="connsiteY0" fmla="*/ 37071 h 444844"/>
              <a:gd name="connsiteX1" fmla="*/ 61784 w 1149178"/>
              <a:gd name="connsiteY1" fmla="*/ 98854 h 444844"/>
              <a:gd name="connsiteX2" fmla="*/ 37070 w 1149178"/>
              <a:gd name="connsiteY2" fmla="*/ 135925 h 444844"/>
              <a:gd name="connsiteX3" fmla="*/ 0 w 1149178"/>
              <a:gd name="connsiteY3" fmla="*/ 160638 h 444844"/>
              <a:gd name="connsiteX4" fmla="*/ 12357 w 1149178"/>
              <a:gd name="connsiteY4" fmla="*/ 321276 h 444844"/>
              <a:gd name="connsiteX5" fmla="*/ 24713 w 1149178"/>
              <a:gd name="connsiteY5" fmla="*/ 358346 h 444844"/>
              <a:gd name="connsiteX6" fmla="*/ 61784 w 1149178"/>
              <a:gd name="connsiteY6" fmla="*/ 383060 h 444844"/>
              <a:gd name="connsiteX7" fmla="*/ 86497 w 1149178"/>
              <a:gd name="connsiteY7" fmla="*/ 420130 h 444844"/>
              <a:gd name="connsiteX8" fmla="*/ 160638 w 1149178"/>
              <a:gd name="connsiteY8" fmla="*/ 444844 h 444844"/>
              <a:gd name="connsiteX9" fmla="*/ 457200 w 1149178"/>
              <a:gd name="connsiteY9" fmla="*/ 432487 h 444844"/>
              <a:gd name="connsiteX10" fmla="*/ 593124 w 1149178"/>
              <a:gd name="connsiteY10" fmla="*/ 407773 h 444844"/>
              <a:gd name="connsiteX11" fmla="*/ 679621 w 1149178"/>
              <a:gd name="connsiteY11" fmla="*/ 395416 h 444844"/>
              <a:gd name="connsiteX12" fmla="*/ 753762 w 1149178"/>
              <a:gd name="connsiteY12" fmla="*/ 370703 h 444844"/>
              <a:gd name="connsiteX13" fmla="*/ 790832 w 1149178"/>
              <a:gd name="connsiteY13" fmla="*/ 345989 h 444844"/>
              <a:gd name="connsiteX14" fmla="*/ 1149178 w 1149178"/>
              <a:gd name="connsiteY14" fmla="*/ 333633 h 444844"/>
              <a:gd name="connsiteX15" fmla="*/ 1136821 w 1149178"/>
              <a:gd name="connsiteY15" fmla="*/ 172995 h 444844"/>
              <a:gd name="connsiteX16" fmla="*/ 1099751 w 1149178"/>
              <a:gd name="connsiteY16" fmla="*/ 148281 h 444844"/>
              <a:gd name="connsiteX17" fmla="*/ 1062681 w 1149178"/>
              <a:gd name="connsiteY17" fmla="*/ 111211 h 444844"/>
              <a:gd name="connsiteX18" fmla="*/ 951470 w 1149178"/>
              <a:gd name="connsiteY18" fmla="*/ 49427 h 444844"/>
              <a:gd name="connsiteX19" fmla="*/ 914400 w 1149178"/>
              <a:gd name="connsiteY19" fmla="*/ 12357 h 444844"/>
              <a:gd name="connsiteX20" fmla="*/ 864973 w 1149178"/>
              <a:gd name="connsiteY20" fmla="*/ 0 h 444844"/>
              <a:gd name="connsiteX21" fmla="*/ 358346 w 1149178"/>
              <a:gd name="connsiteY21" fmla="*/ 12357 h 444844"/>
              <a:gd name="connsiteX22" fmla="*/ 210065 w 1149178"/>
              <a:gd name="connsiteY22" fmla="*/ 24714 h 444844"/>
              <a:gd name="connsiteX23" fmla="*/ 111211 w 1149178"/>
              <a:gd name="connsiteY23" fmla="*/ 37071 h 4448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</a:cxnLst>
            <a:rect l="l" t="t" r="r" b="b"/>
            <a:pathLst>
              <a:path w="1149178" h="444844">
                <a:moveTo>
                  <a:pt x="111211" y="37071"/>
                </a:moveTo>
                <a:cubicBezTo>
                  <a:pt x="86498" y="49428"/>
                  <a:pt x="77608" y="77755"/>
                  <a:pt x="61784" y="98854"/>
                </a:cubicBezTo>
                <a:cubicBezTo>
                  <a:pt x="52873" y="110735"/>
                  <a:pt x="47571" y="125424"/>
                  <a:pt x="37070" y="135925"/>
                </a:cubicBezTo>
                <a:cubicBezTo>
                  <a:pt x="26569" y="146426"/>
                  <a:pt x="12357" y="152400"/>
                  <a:pt x="0" y="160638"/>
                </a:cubicBezTo>
                <a:cubicBezTo>
                  <a:pt x="4119" y="214184"/>
                  <a:pt x="5696" y="267987"/>
                  <a:pt x="12357" y="321276"/>
                </a:cubicBezTo>
                <a:cubicBezTo>
                  <a:pt x="13973" y="334200"/>
                  <a:pt x="16576" y="348175"/>
                  <a:pt x="24713" y="358346"/>
                </a:cubicBezTo>
                <a:cubicBezTo>
                  <a:pt x="33990" y="369943"/>
                  <a:pt x="49427" y="374822"/>
                  <a:pt x="61784" y="383060"/>
                </a:cubicBezTo>
                <a:cubicBezTo>
                  <a:pt x="70022" y="395417"/>
                  <a:pt x="73904" y="412259"/>
                  <a:pt x="86497" y="420130"/>
                </a:cubicBezTo>
                <a:cubicBezTo>
                  <a:pt x="108588" y="433937"/>
                  <a:pt x="160638" y="444844"/>
                  <a:pt x="160638" y="444844"/>
                </a:cubicBezTo>
                <a:cubicBezTo>
                  <a:pt x="259492" y="440725"/>
                  <a:pt x="358453" y="438659"/>
                  <a:pt x="457200" y="432487"/>
                </a:cubicBezTo>
                <a:cubicBezTo>
                  <a:pt x="687703" y="418080"/>
                  <a:pt x="477983" y="430802"/>
                  <a:pt x="593124" y="407773"/>
                </a:cubicBezTo>
                <a:cubicBezTo>
                  <a:pt x="621683" y="402061"/>
                  <a:pt x="650789" y="399535"/>
                  <a:pt x="679621" y="395416"/>
                </a:cubicBezTo>
                <a:cubicBezTo>
                  <a:pt x="704335" y="387178"/>
                  <a:pt x="732087" y="385153"/>
                  <a:pt x="753762" y="370703"/>
                </a:cubicBezTo>
                <a:cubicBezTo>
                  <a:pt x="766119" y="362465"/>
                  <a:pt x="776046" y="347375"/>
                  <a:pt x="790832" y="345989"/>
                </a:cubicBezTo>
                <a:cubicBezTo>
                  <a:pt x="909830" y="334833"/>
                  <a:pt x="1029729" y="337752"/>
                  <a:pt x="1149178" y="333633"/>
                </a:cubicBezTo>
                <a:cubicBezTo>
                  <a:pt x="1145059" y="280087"/>
                  <a:pt x="1150659" y="224886"/>
                  <a:pt x="1136821" y="172995"/>
                </a:cubicBezTo>
                <a:cubicBezTo>
                  <a:pt x="1132994" y="158645"/>
                  <a:pt x="1111160" y="157788"/>
                  <a:pt x="1099751" y="148281"/>
                </a:cubicBezTo>
                <a:cubicBezTo>
                  <a:pt x="1086326" y="137094"/>
                  <a:pt x="1076475" y="121940"/>
                  <a:pt x="1062681" y="111211"/>
                </a:cubicBezTo>
                <a:cubicBezTo>
                  <a:pt x="998948" y="61641"/>
                  <a:pt x="1007401" y="68071"/>
                  <a:pt x="951470" y="49427"/>
                </a:cubicBezTo>
                <a:cubicBezTo>
                  <a:pt x="939113" y="37070"/>
                  <a:pt x="929573" y="21027"/>
                  <a:pt x="914400" y="12357"/>
                </a:cubicBezTo>
                <a:cubicBezTo>
                  <a:pt x="899655" y="3931"/>
                  <a:pt x="881956" y="0"/>
                  <a:pt x="864973" y="0"/>
                </a:cubicBezTo>
                <a:cubicBezTo>
                  <a:pt x="696047" y="0"/>
                  <a:pt x="527222" y="8238"/>
                  <a:pt x="358346" y="12357"/>
                </a:cubicBezTo>
                <a:cubicBezTo>
                  <a:pt x="308919" y="16476"/>
                  <a:pt x="259115" y="17357"/>
                  <a:pt x="210065" y="24714"/>
                </a:cubicBezTo>
                <a:cubicBezTo>
                  <a:pt x="38651" y="50426"/>
                  <a:pt x="135924" y="24714"/>
                  <a:pt x="111211" y="37071"/>
                </a:cubicBezTo>
                <a:close/>
              </a:path>
            </a:pathLst>
          </a:custGeom>
          <a:noFill/>
          <a:ln w="12700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60C909D0-4AA5-4C32-9047-7D32441E64D3}"/>
              </a:ext>
            </a:extLst>
          </p:cNvPr>
          <p:cNvCxnSpPr>
            <a:cxnSpLocks/>
            <a:stCxn id="6" idx="15"/>
            <a:endCxn id="51" idx="1"/>
          </p:cNvCxnSpPr>
          <p:nvPr/>
        </p:nvCxnSpPr>
        <p:spPr>
          <a:xfrm>
            <a:off x="3076832" y="2496065"/>
            <a:ext cx="377451" cy="221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65">
            <a:extLst>
              <a:ext uri="{FF2B5EF4-FFF2-40B4-BE49-F238E27FC236}">
                <a16:creationId xmlns:a16="http://schemas.microsoft.com/office/drawing/2014/main" id="{3E31240E-BBB1-4126-ACED-C0C91C3A5883}"/>
              </a:ext>
            </a:extLst>
          </p:cNvPr>
          <p:cNvSpPr txBox="1"/>
          <p:nvPr/>
        </p:nvSpPr>
        <p:spPr>
          <a:xfrm>
            <a:off x="3454283" y="2379704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</p:txBody>
      </p:sp>
      <p:sp>
        <p:nvSpPr>
          <p:cNvPr id="10" name="Freeform: Shape 9">
            <a:extLst>
              <a:ext uri="{FF2B5EF4-FFF2-40B4-BE49-F238E27FC236}">
                <a16:creationId xmlns:a16="http://schemas.microsoft.com/office/drawing/2014/main" id="{AD42484A-2CB5-46C1-9761-5A495609B3B9}"/>
              </a:ext>
            </a:extLst>
          </p:cNvPr>
          <p:cNvSpPr/>
          <p:nvPr/>
        </p:nvSpPr>
        <p:spPr>
          <a:xfrm>
            <a:off x="2248930" y="2656703"/>
            <a:ext cx="914400" cy="457200"/>
          </a:xfrm>
          <a:custGeom>
            <a:avLst/>
            <a:gdLst>
              <a:gd name="connsiteX0" fmla="*/ 741405 w 914400"/>
              <a:gd name="connsiteY0" fmla="*/ 0 h 457200"/>
              <a:gd name="connsiteX1" fmla="*/ 506627 w 914400"/>
              <a:gd name="connsiteY1" fmla="*/ 12356 h 457200"/>
              <a:gd name="connsiteX2" fmla="*/ 432486 w 914400"/>
              <a:gd name="connsiteY2" fmla="*/ 37070 h 457200"/>
              <a:gd name="connsiteX3" fmla="*/ 345989 w 914400"/>
              <a:gd name="connsiteY3" fmla="*/ 61783 h 457200"/>
              <a:gd name="connsiteX4" fmla="*/ 234778 w 914400"/>
              <a:gd name="connsiteY4" fmla="*/ 148281 h 457200"/>
              <a:gd name="connsiteX5" fmla="*/ 197708 w 914400"/>
              <a:gd name="connsiteY5" fmla="*/ 172994 h 457200"/>
              <a:gd name="connsiteX6" fmla="*/ 37070 w 914400"/>
              <a:gd name="connsiteY6" fmla="*/ 172994 h 457200"/>
              <a:gd name="connsiteX7" fmla="*/ 0 w 914400"/>
              <a:gd name="connsiteY7" fmla="*/ 197708 h 457200"/>
              <a:gd name="connsiteX8" fmla="*/ 12356 w 914400"/>
              <a:gd name="connsiteY8" fmla="*/ 321275 h 457200"/>
              <a:gd name="connsiteX9" fmla="*/ 49427 w 914400"/>
              <a:gd name="connsiteY9" fmla="*/ 333632 h 457200"/>
              <a:gd name="connsiteX10" fmla="*/ 123567 w 914400"/>
              <a:gd name="connsiteY10" fmla="*/ 383059 h 457200"/>
              <a:gd name="connsiteX11" fmla="*/ 197708 w 914400"/>
              <a:gd name="connsiteY11" fmla="*/ 407773 h 457200"/>
              <a:gd name="connsiteX12" fmla="*/ 234778 w 914400"/>
              <a:gd name="connsiteY12" fmla="*/ 432486 h 457200"/>
              <a:gd name="connsiteX13" fmla="*/ 308919 w 914400"/>
              <a:gd name="connsiteY13" fmla="*/ 457200 h 457200"/>
              <a:gd name="connsiteX14" fmla="*/ 481913 w 914400"/>
              <a:gd name="connsiteY14" fmla="*/ 432486 h 457200"/>
              <a:gd name="connsiteX15" fmla="*/ 580767 w 914400"/>
              <a:gd name="connsiteY15" fmla="*/ 407773 h 457200"/>
              <a:gd name="connsiteX16" fmla="*/ 753762 w 914400"/>
              <a:gd name="connsiteY16" fmla="*/ 383059 h 457200"/>
              <a:gd name="connsiteX17" fmla="*/ 803189 w 914400"/>
              <a:gd name="connsiteY17" fmla="*/ 370702 h 457200"/>
              <a:gd name="connsiteX18" fmla="*/ 840259 w 914400"/>
              <a:gd name="connsiteY18" fmla="*/ 345989 h 457200"/>
              <a:gd name="connsiteX19" fmla="*/ 864973 w 914400"/>
              <a:gd name="connsiteY19" fmla="*/ 308919 h 457200"/>
              <a:gd name="connsiteX20" fmla="*/ 902043 w 914400"/>
              <a:gd name="connsiteY20" fmla="*/ 271848 h 457200"/>
              <a:gd name="connsiteX21" fmla="*/ 914400 w 914400"/>
              <a:gd name="connsiteY21" fmla="*/ 234778 h 457200"/>
              <a:gd name="connsiteX22" fmla="*/ 902043 w 914400"/>
              <a:gd name="connsiteY22" fmla="*/ 185351 h 457200"/>
              <a:gd name="connsiteX23" fmla="*/ 778475 w 914400"/>
              <a:gd name="connsiteY23" fmla="*/ 61783 h 457200"/>
              <a:gd name="connsiteX24" fmla="*/ 704335 w 914400"/>
              <a:gd name="connsiteY24" fmla="*/ 37070 h 457200"/>
              <a:gd name="connsiteX25" fmla="*/ 667265 w 914400"/>
              <a:gd name="connsiteY25" fmla="*/ 24713 h 457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914400" h="457200">
                <a:moveTo>
                  <a:pt x="741405" y="0"/>
                </a:moveTo>
                <a:cubicBezTo>
                  <a:pt x="663146" y="4119"/>
                  <a:pt x="584436" y="3019"/>
                  <a:pt x="506627" y="12356"/>
                </a:cubicBezTo>
                <a:cubicBezTo>
                  <a:pt x="480762" y="15460"/>
                  <a:pt x="457759" y="30752"/>
                  <a:pt x="432486" y="37070"/>
                </a:cubicBezTo>
                <a:cubicBezTo>
                  <a:pt x="370423" y="52586"/>
                  <a:pt x="399170" y="44057"/>
                  <a:pt x="345989" y="61783"/>
                </a:cubicBezTo>
                <a:cubicBezTo>
                  <a:pt x="287917" y="119857"/>
                  <a:pt x="323459" y="89161"/>
                  <a:pt x="234778" y="148281"/>
                </a:cubicBezTo>
                <a:lnTo>
                  <a:pt x="197708" y="172994"/>
                </a:lnTo>
                <a:cubicBezTo>
                  <a:pt x="130229" y="164560"/>
                  <a:pt x="98393" y="149998"/>
                  <a:pt x="37070" y="172994"/>
                </a:cubicBezTo>
                <a:cubicBezTo>
                  <a:pt x="23165" y="178208"/>
                  <a:pt x="12357" y="189470"/>
                  <a:pt x="0" y="197708"/>
                </a:cubicBezTo>
                <a:cubicBezTo>
                  <a:pt x="4119" y="238897"/>
                  <a:pt x="-1790" y="282373"/>
                  <a:pt x="12356" y="321275"/>
                </a:cubicBezTo>
                <a:cubicBezTo>
                  <a:pt x="16807" y="333516"/>
                  <a:pt x="39256" y="325495"/>
                  <a:pt x="49427" y="333632"/>
                </a:cubicBezTo>
                <a:cubicBezTo>
                  <a:pt x="136931" y="403635"/>
                  <a:pt x="-1300" y="345598"/>
                  <a:pt x="123567" y="383059"/>
                </a:cubicBezTo>
                <a:cubicBezTo>
                  <a:pt x="148519" y="390545"/>
                  <a:pt x="176033" y="393323"/>
                  <a:pt x="197708" y="407773"/>
                </a:cubicBezTo>
                <a:cubicBezTo>
                  <a:pt x="210065" y="416011"/>
                  <a:pt x="221207" y="426455"/>
                  <a:pt x="234778" y="432486"/>
                </a:cubicBezTo>
                <a:cubicBezTo>
                  <a:pt x="258583" y="443066"/>
                  <a:pt x="308919" y="457200"/>
                  <a:pt x="308919" y="457200"/>
                </a:cubicBezTo>
                <a:cubicBezTo>
                  <a:pt x="396093" y="447514"/>
                  <a:pt x="408844" y="449348"/>
                  <a:pt x="481913" y="432486"/>
                </a:cubicBezTo>
                <a:cubicBezTo>
                  <a:pt x="515009" y="424849"/>
                  <a:pt x="547064" y="411986"/>
                  <a:pt x="580767" y="407773"/>
                </a:cubicBezTo>
                <a:cubicBezTo>
                  <a:pt x="641511" y="400180"/>
                  <a:pt x="694376" y="394936"/>
                  <a:pt x="753762" y="383059"/>
                </a:cubicBezTo>
                <a:cubicBezTo>
                  <a:pt x="770415" y="379728"/>
                  <a:pt x="786713" y="374821"/>
                  <a:pt x="803189" y="370702"/>
                </a:cubicBezTo>
                <a:cubicBezTo>
                  <a:pt x="815546" y="362464"/>
                  <a:pt x="829758" y="356490"/>
                  <a:pt x="840259" y="345989"/>
                </a:cubicBezTo>
                <a:cubicBezTo>
                  <a:pt x="850760" y="335488"/>
                  <a:pt x="855466" y="320328"/>
                  <a:pt x="864973" y="308919"/>
                </a:cubicBezTo>
                <a:cubicBezTo>
                  <a:pt x="876160" y="295494"/>
                  <a:pt x="889686" y="284205"/>
                  <a:pt x="902043" y="271848"/>
                </a:cubicBezTo>
                <a:cubicBezTo>
                  <a:pt x="906162" y="259491"/>
                  <a:pt x="914400" y="247803"/>
                  <a:pt x="914400" y="234778"/>
                </a:cubicBezTo>
                <a:cubicBezTo>
                  <a:pt x="914400" y="217795"/>
                  <a:pt x="909638" y="200541"/>
                  <a:pt x="902043" y="185351"/>
                </a:cubicBezTo>
                <a:cubicBezTo>
                  <a:pt x="875682" y="132630"/>
                  <a:pt x="837786" y="81553"/>
                  <a:pt x="778475" y="61783"/>
                </a:cubicBezTo>
                <a:lnTo>
                  <a:pt x="704335" y="37070"/>
                </a:lnTo>
                <a:lnTo>
                  <a:pt x="667265" y="24713"/>
                </a:lnTo>
              </a:path>
            </a:pathLst>
          </a:custGeom>
          <a:noFill/>
          <a:ln w="12700">
            <a:solidFill>
              <a:srgbClr val="00B05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A8B4DFC5-529C-4540-AF81-DDBFA1770F70}"/>
              </a:ext>
            </a:extLst>
          </p:cNvPr>
          <p:cNvCxnSpPr>
            <a:cxnSpLocks/>
          </p:cNvCxnSpPr>
          <p:nvPr/>
        </p:nvCxnSpPr>
        <p:spPr>
          <a:xfrm flipV="1">
            <a:off x="3163350" y="2917468"/>
            <a:ext cx="366673" cy="32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65">
            <a:extLst>
              <a:ext uri="{FF2B5EF4-FFF2-40B4-BE49-F238E27FC236}">
                <a16:creationId xmlns:a16="http://schemas.microsoft.com/office/drawing/2014/main" id="{B354E76B-FB37-40C5-9C10-DA758D3A7FF2}"/>
              </a:ext>
            </a:extLst>
          </p:cNvPr>
          <p:cNvSpPr txBox="1"/>
          <p:nvPr/>
        </p:nvSpPr>
        <p:spPr>
          <a:xfrm>
            <a:off x="3463705" y="2718414"/>
            <a:ext cx="7745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ymus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ganoid</a:t>
            </a:r>
          </a:p>
        </p:txBody>
      </p:sp>
      <p:sp>
        <p:nvSpPr>
          <p:cNvPr id="54" name="TextBox 65">
            <a:extLst>
              <a:ext uri="{FF2B5EF4-FFF2-40B4-BE49-F238E27FC236}">
                <a16:creationId xmlns:a16="http://schemas.microsoft.com/office/drawing/2014/main" id="{0F4FAFB7-3A7F-45E2-9A5B-96644B302619}"/>
              </a:ext>
            </a:extLst>
          </p:cNvPr>
          <p:cNvSpPr txBox="1"/>
          <p:nvPr/>
        </p:nvSpPr>
        <p:spPr>
          <a:xfrm>
            <a:off x="3121454" y="3328785"/>
            <a:ext cx="17251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Gated on huCD45+ cells</a:t>
            </a:r>
          </a:p>
        </p:txBody>
      </p:sp>
    </p:spTree>
    <p:extLst>
      <p:ext uri="{BB962C8B-B14F-4D97-AF65-F5344CB8AC3E}">
        <p14:creationId xmlns:p14="http://schemas.microsoft.com/office/powerpoint/2010/main" val="2469424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>
            <a:extLst>
              <a:ext uri="{FF2B5EF4-FFF2-40B4-BE49-F238E27FC236}">
                <a16:creationId xmlns:a16="http://schemas.microsoft.com/office/drawing/2014/main" id="{5905BF09-3981-4AD4-87E1-49A07DD1E0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1763" y="156639"/>
            <a:ext cx="1577460" cy="16957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id="{AC2A71DC-8CC3-4D3E-9B59-DC5086478E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897" y="144418"/>
            <a:ext cx="1600200" cy="17202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7">
            <a:extLst>
              <a:ext uri="{FF2B5EF4-FFF2-40B4-BE49-F238E27FC236}">
                <a16:creationId xmlns:a16="http://schemas.microsoft.com/office/drawing/2014/main" id="{AD4C643D-DA90-481C-9DD5-FC8C0F1E0A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3630" y="1906500"/>
            <a:ext cx="1780634" cy="17206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9">
            <a:extLst>
              <a:ext uri="{FF2B5EF4-FFF2-40B4-BE49-F238E27FC236}">
                <a16:creationId xmlns:a16="http://schemas.microsoft.com/office/drawing/2014/main" id="{CA83B9A0-F07D-47C3-8962-DABC2A706F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4391" y="3821512"/>
            <a:ext cx="1695450" cy="18097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10">
            <a:extLst>
              <a:ext uri="{FF2B5EF4-FFF2-40B4-BE49-F238E27FC236}">
                <a16:creationId xmlns:a16="http://schemas.microsoft.com/office/drawing/2014/main" id="{6DF5E3D6-6450-4F68-879B-5D2D30D44F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2379" y="2503240"/>
            <a:ext cx="169545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6D6AC52F-451B-425E-BFF1-A18C60C5BAE9}"/>
              </a:ext>
            </a:extLst>
          </p:cNvPr>
          <p:cNvCxnSpPr>
            <a:cxnSpLocks/>
          </p:cNvCxnSpPr>
          <p:nvPr/>
        </p:nvCxnSpPr>
        <p:spPr>
          <a:xfrm>
            <a:off x="1857254" y="1279393"/>
            <a:ext cx="609601" cy="0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74DB230F-B449-462A-A7B5-51651E75CA21}"/>
              </a:ext>
            </a:extLst>
          </p:cNvPr>
          <p:cNvCxnSpPr>
            <a:cxnSpLocks/>
          </p:cNvCxnSpPr>
          <p:nvPr/>
        </p:nvCxnSpPr>
        <p:spPr>
          <a:xfrm>
            <a:off x="3242505" y="2997151"/>
            <a:ext cx="0" cy="994778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3197706-5BAE-458D-82C9-3B6CFF74ED71}"/>
              </a:ext>
            </a:extLst>
          </p:cNvPr>
          <p:cNvCxnSpPr/>
          <p:nvPr/>
        </p:nvCxnSpPr>
        <p:spPr>
          <a:xfrm flipV="1">
            <a:off x="6383320" y="3151056"/>
            <a:ext cx="351714" cy="28575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E529AD76-6519-40CD-B249-3141D49B1C12}"/>
              </a:ext>
            </a:extLst>
          </p:cNvPr>
          <p:cNvSpPr txBox="1"/>
          <p:nvPr/>
        </p:nvSpPr>
        <p:spPr>
          <a:xfrm>
            <a:off x="6674547" y="2986154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>
                <a:solidFill>
                  <a:prstClr val="black"/>
                </a:solidFill>
              </a:rPr>
              <a:t>Monocytes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1DEA84B-5BAD-4684-A69B-0FEFC26F1D88}"/>
              </a:ext>
            </a:extLst>
          </p:cNvPr>
          <p:cNvCxnSpPr/>
          <p:nvPr/>
        </p:nvCxnSpPr>
        <p:spPr>
          <a:xfrm>
            <a:off x="6427933" y="3871982"/>
            <a:ext cx="41910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B3F91EBE-1987-49E7-95CA-AC0BC9796039}"/>
              </a:ext>
            </a:extLst>
          </p:cNvPr>
          <p:cNvSpPr txBox="1"/>
          <p:nvPr/>
        </p:nvSpPr>
        <p:spPr>
          <a:xfrm>
            <a:off x="6769469" y="369316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 err="1">
                <a:solidFill>
                  <a:prstClr val="black"/>
                </a:solidFill>
              </a:rPr>
              <a:t>cDCs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FF782C0-C658-47DE-B363-467FD397B8F7}"/>
              </a:ext>
            </a:extLst>
          </p:cNvPr>
          <p:cNvSpPr/>
          <p:nvPr/>
        </p:nvSpPr>
        <p:spPr>
          <a:xfrm>
            <a:off x="2991050" y="2357034"/>
            <a:ext cx="484823" cy="29241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233784CE-F14A-411C-AFDC-998D356C02A1}"/>
              </a:ext>
            </a:extLst>
          </p:cNvPr>
          <p:cNvCxnSpPr>
            <a:cxnSpLocks/>
          </p:cNvCxnSpPr>
          <p:nvPr/>
        </p:nvCxnSpPr>
        <p:spPr>
          <a:xfrm flipH="1">
            <a:off x="2423630" y="2503240"/>
            <a:ext cx="643623" cy="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D5284296-2DEC-459C-8BEC-E4EDECBEB9D1}"/>
              </a:ext>
            </a:extLst>
          </p:cNvPr>
          <p:cNvSpPr txBox="1"/>
          <p:nvPr/>
        </p:nvSpPr>
        <p:spPr>
          <a:xfrm>
            <a:off x="1862409" y="2402148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>
                <a:solidFill>
                  <a:prstClr val="black"/>
                </a:solidFill>
              </a:rPr>
              <a:t>T cell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BEA3448-FE2F-4458-80D1-F58A50EFFAC1}"/>
              </a:ext>
            </a:extLst>
          </p:cNvPr>
          <p:cNvSpPr/>
          <p:nvPr/>
        </p:nvSpPr>
        <p:spPr>
          <a:xfrm>
            <a:off x="3489521" y="2649449"/>
            <a:ext cx="321797" cy="61245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4296E09F-94D2-44D2-B546-53551F19B20A}"/>
              </a:ext>
            </a:extLst>
          </p:cNvPr>
          <p:cNvCxnSpPr/>
          <p:nvPr/>
        </p:nvCxnSpPr>
        <p:spPr>
          <a:xfrm>
            <a:off x="3650417" y="3182851"/>
            <a:ext cx="0" cy="55399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EB9396EB-EC51-4DA0-A8E4-EB34F51286C8}"/>
              </a:ext>
            </a:extLst>
          </p:cNvPr>
          <p:cNvSpPr txBox="1"/>
          <p:nvPr/>
        </p:nvSpPr>
        <p:spPr>
          <a:xfrm>
            <a:off x="3342231" y="3696953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>
                <a:solidFill>
                  <a:prstClr val="black"/>
                </a:solidFill>
              </a:rPr>
              <a:t>B cells</a:t>
            </a:r>
          </a:p>
        </p:txBody>
      </p:sp>
      <p:pic>
        <p:nvPicPr>
          <p:cNvPr id="24" name="Picture 2">
            <a:extLst>
              <a:ext uri="{FF2B5EF4-FFF2-40B4-BE49-F238E27FC236}">
                <a16:creationId xmlns:a16="http://schemas.microsoft.com/office/drawing/2014/main" id="{EA606888-2C7B-4868-843E-11DC517C4EE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7779" y="4307158"/>
            <a:ext cx="1524000" cy="18097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984FC1A3-B1D0-413C-8FA7-69914BBBCBB3}"/>
              </a:ext>
            </a:extLst>
          </p:cNvPr>
          <p:cNvCxnSpPr/>
          <p:nvPr/>
        </p:nvCxnSpPr>
        <p:spPr>
          <a:xfrm>
            <a:off x="6139429" y="5022734"/>
            <a:ext cx="52842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07EA7A81-40FF-4817-84CF-558849A96A54}"/>
              </a:ext>
            </a:extLst>
          </p:cNvPr>
          <p:cNvSpPr txBox="1"/>
          <p:nvPr/>
        </p:nvSpPr>
        <p:spPr>
          <a:xfrm>
            <a:off x="6601831" y="485431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 err="1">
                <a:solidFill>
                  <a:prstClr val="black"/>
                </a:solidFill>
              </a:rPr>
              <a:t>pDCs</a:t>
            </a:r>
            <a:endParaRPr lang="en-US" b="1" dirty="0">
              <a:solidFill>
                <a:prstClr val="black"/>
              </a:solidFill>
            </a:endParaRPr>
          </a:p>
        </p:txBody>
      </p:sp>
      <p:pic>
        <p:nvPicPr>
          <p:cNvPr id="28" name="Picture 6">
            <a:extLst>
              <a:ext uri="{FF2B5EF4-FFF2-40B4-BE49-F238E27FC236}">
                <a16:creationId xmlns:a16="http://schemas.microsoft.com/office/drawing/2014/main" id="{072512B1-E09D-42A6-AA5D-04B0717576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2779" y="214110"/>
            <a:ext cx="1524000" cy="163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60C24E49-7F9F-41AB-B6B4-49B4E31C8C50}"/>
              </a:ext>
            </a:extLst>
          </p:cNvPr>
          <p:cNvCxnSpPr/>
          <p:nvPr/>
        </p:nvCxnSpPr>
        <p:spPr>
          <a:xfrm flipV="1">
            <a:off x="4982379" y="214110"/>
            <a:ext cx="0" cy="63448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4B7366C1-96FD-4D6F-94E3-E52562C8DD81}"/>
              </a:ext>
            </a:extLst>
          </p:cNvPr>
          <p:cNvSpPr txBox="1"/>
          <p:nvPr/>
        </p:nvSpPr>
        <p:spPr>
          <a:xfrm>
            <a:off x="4587078" y="18139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>
                <a:solidFill>
                  <a:prstClr val="black"/>
                </a:solidFill>
              </a:rPr>
              <a:t>NK cells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26D13B4F-C7EC-4AB0-9668-A392A5877A6C}"/>
              </a:ext>
            </a:extLst>
          </p:cNvPr>
          <p:cNvCxnSpPr>
            <a:cxnSpLocks/>
          </p:cNvCxnSpPr>
          <p:nvPr/>
        </p:nvCxnSpPr>
        <p:spPr>
          <a:xfrm>
            <a:off x="3266790" y="728576"/>
            <a:ext cx="1105989" cy="0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E8F0516D-C83B-43AD-BC40-9E7C226BA7D6}"/>
              </a:ext>
            </a:extLst>
          </p:cNvPr>
          <p:cNvSpPr txBox="1"/>
          <p:nvPr/>
        </p:nvSpPr>
        <p:spPr>
          <a:xfrm>
            <a:off x="2637435" y="27109"/>
            <a:ext cx="11448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>
                <a:solidFill>
                  <a:prstClr val="black"/>
                </a:solidFill>
              </a:rPr>
              <a:t>hCD45</a:t>
            </a:r>
            <a:r>
              <a:rPr lang="en-US" baseline="30000" dirty="0">
                <a:solidFill>
                  <a:prstClr val="black"/>
                </a:solidFill>
              </a:rPr>
              <a:t>+</a:t>
            </a:r>
            <a:r>
              <a:rPr lang="en-US" dirty="0">
                <a:solidFill>
                  <a:prstClr val="black"/>
                </a:solidFill>
              </a:rPr>
              <a:t> cells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6C62CE67-C651-427E-AFB4-280DA847A6D0}"/>
              </a:ext>
            </a:extLst>
          </p:cNvPr>
          <p:cNvCxnSpPr>
            <a:cxnSpLocks/>
          </p:cNvCxnSpPr>
          <p:nvPr/>
        </p:nvCxnSpPr>
        <p:spPr>
          <a:xfrm flipV="1">
            <a:off x="2981560" y="214110"/>
            <a:ext cx="0" cy="3172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D60461EB-316E-41C7-8EF3-E9962CD43000}"/>
              </a:ext>
            </a:extLst>
          </p:cNvPr>
          <p:cNvCxnSpPr>
            <a:cxnSpLocks/>
            <a:endCxn id="9" idx="1"/>
          </p:cNvCxnSpPr>
          <p:nvPr/>
        </p:nvCxnSpPr>
        <p:spPr>
          <a:xfrm flipV="1">
            <a:off x="3651269" y="3417640"/>
            <a:ext cx="1331110" cy="889518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BA297FB1-232C-4650-87A6-AE182CE7A0AF}"/>
              </a:ext>
            </a:extLst>
          </p:cNvPr>
          <p:cNvCxnSpPr>
            <a:cxnSpLocks/>
          </p:cNvCxnSpPr>
          <p:nvPr/>
        </p:nvCxnSpPr>
        <p:spPr>
          <a:xfrm>
            <a:off x="3693745" y="4665852"/>
            <a:ext cx="1214110" cy="752476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687CA102-152C-4A10-B5A9-35BD48269336}"/>
              </a:ext>
            </a:extLst>
          </p:cNvPr>
          <p:cNvSpPr txBox="1"/>
          <p:nvPr/>
        </p:nvSpPr>
        <p:spPr>
          <a:xfrm>
            <a:off x="5899618" y="-19058"/>
            <a:ext cx="3342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 Cheng et al.  Supplemental Fig. 2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2050693E-3DE2-4B74-9B5B-B84D1871C4B7}"/>
              </a:ext>
            </a:extLst>
          </p:cNvPr>
          <p:cNvCxnSpPr>
            <a:cxnSpLocks/>
          </p:cNvCxnSpPr>
          <p:nvPr/>
        </p:nvCxnSpPr>
        <p:spPr>
          <a:xfrm>
            <a:off x="3067253" y="848594"/>
            <a:ext cx="0" cy="1280652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4186688D-A368-4D3D-B24C-1D4D4761EC22}"/>
              </a:ext>
            </a:extLst>
          </p:cNvPr>
          <p:cNvSpPr/>
          <p:nvPr/>
        </p:nvSpPr>
        <p:spPr>
          <a:xfrm>
            <a:off x="164527" y="6086115"/>
            <a:ext cx="780558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Gating stratagem for human immune cells in humanized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umanized mice were developed as indicated in Materials and Methods. Representative dot plot showed human immune cells in peripheral blood of humanized mice twelve weeks after reconstitution. </a:t>
            </a:r>
          </a:p>
        </p:txBody>
      </p:sp>
    </p:spTree>
    <p:extLst>
      <p:ext uri="{BB962C8B-B14F-4D97-AF65-F5344CB8AC3E}">
        <p14:creationId xmlns:p14="http://schemas.microsoft.com/office/powerpoint/2010/main" val="13814956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C404911-3D79-4074-A0E7-D6714854537F}"/>
              </a:ext>
            </a:extLst>
          </p:cNvPr>
          <p:cNvGrpSpPr/>
          <p:nvPr/>
        </p:nvGrpSpPr>
        <p:grpSpPr>
          <a:xfrm>
            <a:off x="2994815" y="530393"/>
            <a:ext cx="2392620" cy="2925146"/>
            <a:chOff x="7122679" y="464620"/>
            <a:chExt cx="2392620" cy="2925146"/>
          </a:xfrm>
        </p:grpSpPr>
        <p:pic>
          <p:nvPicPr>
            <p:cNvPr id="5" name="Picture 20">
              <a:extLst>
                <a:ext uri="{FF2B5EF4-FFF2-40B4-BE49-F238E27FC236}">
                  <a16:creationId xmlns:a16="http://schemas.microsoft.com/office/drawing/2014/main" id="{72296351-06E1-45FD-9680-53B92D6E045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44" t="12982" b="18020"/>
            <a:stretch/>
          </p:blipFill>
          <p:spPr bwMode="auto">
            <a:xfrm>
              <a:off x="7349719" y="797216"/>
              <a:ext cx="1075082" cy="10410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B2CEEFC-66D5-4555-8E85-A3849A6F23E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44" t="14257" b="18414"/>
            <a:stretch/>
          </p:blipFill>
          <p:spPr bwMode="auto">
            <a:xfrm>
              <a:off x="7330584" y="2141330"/>
              <a:ext cx="1085940" cy="10260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2F0CCFF-5A99-4930-9A23-6B156D9D650F}"/>
                </a:ext>
              </a:extLst>
            </p:cNvPr>
            <p:cNvSpPr txBox="1"/>
            <p:nvPr/>
          </p:nvSpPr>
          <p:spPr>
            <a:xfrm>
              <a:off x="7300214" y="3112767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828A220-8B44-43F7-A3EC-0F5CAC89D405}"/>
                </a:ext>
              </a:extLst>
            </p:cNvPr>
            <p:cNvSpPr txBox="1"/>
            <p:nvPr/>
          </p:nvSpPr>
          <p:spPr>
            <a:xfrm rot="16200000">
              <a:off x="7036598" y="2895213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L-2</a:t>
              </a:r>
            </a:p>
          </p:txBody>
        </p: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E940DDFB-2E65-4160-8211-3F92337FFCD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264125" y="1072741"/>
              <a:ext cx="1" cy="175077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" name="Picture 18">
              <a:extLst>
                <a:ext uri="{FF2B5EF4-FFF2-40B4-BE49-F238E27FC236}">
                  <a16:creationId xmlns:a16="http://schemas.microsoft.com/office/drawing/2014/main" id="{6C6E139D-FC9C-4D41-8D86-72370733E0C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72" t="12967" b="21033"/>
            <a:stretch/>
          </p:blipFill>
          <p:spPr bwMode="auto">
            <a:xfrm>
              <a:off x="8434829" y="2144551"/>
              <a:ext cx="1056561" cy="10058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32065AA-149C-4723-9AC0-D2098EBFAD4C}"/>
                </a:ext>
              </a:extLst>
            </p:cNvPr>
            <p:cNvSpPr txBox="1"/>
            <p:nvPr/>
          </p:nvSpPr>
          <p:spPr>
            <a:xfrm>
              <a:off x="7315766" y="962333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6A3B862-A20E-40D9-839F-81B37F85B4EC}"/>
                </a:ext>
              </a:extLst>
            </p:cNvPr>
            <p:cNvSpPr txBox="1"/>
            <p:nvPr/>
          </p:nvSpPr>
          <p:spPr>
            <a:xfrm>
              <a:off x="7294479" y="2280836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FAB7DC2-AD7E-4CEF-A9AA-294A45116B74}"/>
                </a:ext>
              </a:extLst>
            </p:cNvPr>
            <p:cNvSpPr txBox="1"/>
            <p:nvPr/>
          </p:nvSpPr>
          <p:spPr>
            <a:xfrm>
              <a:off x="7859486" y="2280835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D8942F7-70A8-4322-A121-45141135BB58}"/>
                </a:ext>
              </a:extLst>
            </p:cNvPr>
            <p:cNvSpPr txBox="1"/>
            <p:nvPr/>
          </p:nvSpPr>
          <p:spPr>
            <a:xfrm>
              <a:off x="7860870" y="2822876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4</a:t>
              </a:r>
            </a:p>
          </p:txBody>
        </p:sp>
        <p:pic>
          <p:nvPicPr>
            <p:cNvPr id="15" name="Picture 17">
              <a:extLst>
                <a:ext uri="{FF2B5EF4-FFF2-40B4-BE49-F238E27FC236}">
                  <a16:creationId xmlns:a16="http://schemas.microsoft.com/office/drawing/2014/main" id="{0128218A-1B48-4994-B19A-0BBE908BD72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73" t="13026" b="17977"/>
            <a:stretch/>
          </p:blipFill>
          <p:spPr bwMode="auto">
            <a:xfrm>
              <a:off x="8458754" y="798563"/>
              <a:ext cx="1056545" cy="1051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DE7AE2C-A726-4256-B285-4AF923C83520}"/>
                </a:ext>
              </a:extLst>
            </p:cNvPr>
            <p:cNvSpPr txBox="1"/>
            <p:nvPr/>
          </p:nvSpPr>
          <p:spPr>
            <a:xfrm>
              <a:off x="7954695" y="985891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141523C-AC5F-4867-BB0B-32933B517FDD}"/>
                </a:ext>
              </a:extLst>
            </p:cNvPr>
            <p:cNvSpPr txBox="1"/>
            <p:nvPr/>
          </p:nvSpPr>
          <p:spPr>
            <a:xfrm>
              <a:off x="7307697" y="464620"/>
              <a:ext cx="15327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ated</a:t>
              </a:r>
              <a:r>
                <a: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46244AD-EB34-489D-B19F-1D24AEEEAE72}"/>
                </a:ext>
              </a:extLst>
            </p:cNvPr>
            <p:cNvSpPr txBox="1"/>
            <p:nvPr/>
          </p:nvSpPr>
          <p:spPr>
            <a:xfrm>
              <a:off x="7319545" y="1845842"/>
              <a:ext cx="15327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ated</a:t>
              </a:r>
              <a:r>
                <a: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1505DE5-E416-45E6-9777-8AA92E866DBF}"/>
                </a:ext>
              </a:extLst>
            </p:cNvPr>
            <p:cNvSpPr txBox="1"/>
            <p:nvPr/>
          </p:nvSpPr>
          <p:spPr>
            <a:xfrm>
              <a:off x="8621770" y="643266"/>
              <a:ext cx="64953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05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Hu-BLT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615BBD2-D711-4E7D-BC28-C6B04C3DB09A}"/>
                </a:ext>
              </a:extLst>
            </p:cNvPr>
            <p:cNvSpPr txBox="1"/>
            <p:nvPr/>
          </p:nvSpPr>
          <p:spPr>
            <a:xfrm>
              <a:off x="7539699" y="626392"/>
              <a:ext cx="68800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05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Hu-HSC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1611443-7F7A-4E12-BB78-6D0CECB7F0B8}"/>
                </a:ext>
              </a:extLst>
            </p:cNvPr>
            <p:cNvSpPr txBox="1"/>
            <p:nvPr/>
          </p:nvSpPr>
          <p:spPr>
            <a:xfrm>
              <a:off x="8621767" y="2001015"/>
              <a:ext cx="64953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05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Hu-BLT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765E486-22E6-48AE-8C10-2DC0332346F6}"/>
                </a:ext>
              </a:extLst>
            </p:cNvPr>
            <p:cNvSpPr txBox="1"/>
            <p:nvPr/>
          </p:nvSpPr>
          <p:spPr>
            <a:xfrm>
              <a:off x="7539696" y="1984141"/>
              <a:ext cx="68800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05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Hu-HSC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521B004D-5D0C-4C64-B327-F842E58226B2}"/>
                </a:ext>
              </a:extLst>
            </p:cNvPr>
            <p:cNvCxnSpPr>
              <a:cxnSpLocks/>
            </p:cNvCxnSpPr>
            <p:nvPr/>
          </p:nvCxnSpPr>
          <p:spPr>
            <a:xfrm>
              <a:off x="7804459" y="3266856"/>
              <a:ext cx="140006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D4EE07E-3442-4387-BE18-62865D581DDC}"/>
                </a:ext>
              </a:extLst>
            </p:cNvPr>
            <p:cNvSpPr txBox="1"/>
            <p:nvPr/>
          </p:nvSpPr>
          <p:spPr>
            <a:xfrm>
              <a:off x="7954692" y="1470805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726BDEB-86A6-4184-B54F-BBD8E76ED9D1}"/>
                </a:ext>
              </a:extLst>
            </p:cNvPr>
            <p:cNvSpPr txBox="1"/>
            <p:nvPr/>
          </p:nvSpPr>
          <p:spPr>
            <a:xfrm>
              <a:off x="8410279" y="990039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D6571EF-4A49-4A4A-BFA7-20F1218ADB86}"/>
                </a:ext>
              </a:extLst>
            </p:cNvPr>
            <p:cNvSpPr txBox="1"/>
            <p:nvPr/>
          </p:nvSpPr>
          <p:spPr>
            <a:xfrm>
              <a:off x="9049208" y="1013597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CDDB0C9-D28B-4F35-AEEC-FC33D94AFA52}"/>
                </a:ext>
              </a:extLst>
            </p:cNvPr>
            <p:cNvSpPr txBox="1"/>
            <p:nvPr/>
          </p:nvSpPr>
          <p:spPr>
            <a:xfrm>
              <a:off x="9049205" y="1498511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2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BFA5108-7370-4E72-A598-81E515B142DA}"/>
                </a:ext>
              </a:extLst>
            </p:cNvPr>
            <p:cNvSpPr txBox="1"/>
            <p:nvPr/>
          </p:nvSpPr>
          <p:spPr>
            <a:xfrm>
              <a:off x="8375131" y="229468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F883071-8F15-4D08-9CA7-C6FF608FB88D}"/>
                </a:ext>
              </a:extLst>
            </p:cNvPr>
            <p:cNvSpPr txBox="1"/>
            <p:nvPr/>
          </p:nvSpPr>
          <p:spPr>
            <a:xfrm>
              <a:off x="8941522" y="283672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A6777FF-3E3A-41F1-BA79-2CAC5475C2BF}"/>
                </a:ext>
              </a:extLst>
            </p:cNvPr>
            <p:cNvSpPr txBox="1"/>
            <p:nvPr/>
          </p:nvSpPr>
          <p:spPr>
            <a:xfrm>
              <a:off x="8940672" y="2306309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23C63BEF-38C2-4559-B602-D53E1049879F}"/>
              </a:ext>
            </a:extLst>
          </p:cNvPr>
          <p:cNvSpPr/>
          <p:nvPr/>
        </p:nvSpPr>
        <p:spPr>
          <a:xfrm>
            <a:off x="2143286" y="3503881"/>
            <a:ext cx="47012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plenocytes were cultured ex vivo for 4 hours followed by intracellular cytokine staining. Representative dot plots show percentages of IFN-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γ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IL-2 producing T cells.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F249F61-0233-4E42-8078-7C71B6EDDE6A}"/>
              </a:ext>
            </a:extLst>
          </p:cNvPr>
          <p:cNvSpPr txBox="1"/>
          <p:nvPr/>
        </p:nvSpPr>
        <p:spPr>
          <a:xfrm>
            <a:off x="5899618" y="-19058"/>
            <a:ext cx="3342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 Cheng et al.  Supplemental Fig. 3</a:t>
            </a:r>
          </a:p>
        </p:txBody>
      </p:sp>
    </p:spTree>
    <p:extLst>
      <p:ext uri="{BB962C8B-B14F-4D97-AF65-F5344CB8AC3E}">
        <p14:creationId xmlns:p14="http://schemas.microsoft.com/office/powerpoint/2010/main" val="2965449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297</Words>
  <Application>Microsoft Office PowerPoint</Application>
  <PresentationFormat>On-screen Show (4:3)</PresentationFormat>
  <Paragraphs>4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ang</dc:creator>
  <cp:lastModifiedBy>Liang</cp:lastModifiedBy>
  <cp:revision>14</cp:revision>
  <dcterms:created xsi:type="dcterms:W3CDTF">2017-12-20T03:48:44Z</dcterms:created>
  <dcterms:modified xsi:type="dcterms:W3CDTF">2018-03-13T15:51:37Z</dcterms:modified>
</cp:coreProperties>
</file>